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 showGuides="1">
      <p:cViewPr varScale="1">
        <p:scale>
          <a:sx n="67" d="100"/>
          <a:sy n="67" d="100"/>
        </p:scale>
        <p:origin x="572" y="5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 smtClean="0"/>
              <a:t>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896926-F365-4FC9-9FF3-0DD0749CEB9B}" type="datetimeFigureOut">
              <a:rPr lang="fr-FR" smtClean="0"/>
              <a:t>27/01/202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2E57F0-A141-49CE-9B54-F7B5C2254B0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582315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896926-F365-4FC9-9FF3-0DD0749CEB9B}" type="datetimeFigureOut">
              <a:rPr lang="fr-FR" smtClean="0"/>
              <a:t>27/01/202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2E57F0-A141-49CE-9B54-F7B5C2254B0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219820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896926-F365-4FC9-9FF3-0DD0749CEB9B}" type="datetimeFigureOut">
              <a:rPr lang="fr-FR" smtClean="0"/>
              <a:t>27/01/202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2E57F0-A141-49CE-9B54-F7B5C2254B0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162116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896926-F365-4FC9-9FF3-0DD0749CEB9B}" type="datetimeFigureOut">
              <a:rPr lang="fr-FR" smtClean="0"/>
              <a:t>27/01/202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2E57F0-A141-49CE-9B54-F7B5C2254B0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842906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896926-F365-4FC9-9FF3-0DD0749CEB9B}" type="datetimeFigureOut">
              <a:rPr lang="fr-FR" smtClean="0"/>
              <a:t>27/01/202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2E57F0-A141-49CE-9B54-F7B5C2254B0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948787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896926-F365-4FC9-9FF3-0DD0749CEB9B}" type="datetimeFigureOut">
              <a:rPr lang="fr-FR" smtClean="0"/>
              <a:t>27/01/2025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2E57F0-A141-49CE-9B54-F7B5C2254B0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520508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896926-F365-4FC9-9FF3-0DD0749CEB9B}" type="datetimeFigureOut">
              <a:rPr lang="fr-FR" smtClean="0"/>
              <a:t>27/01/2025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2E57F0-A141-49CE-9B54-F7B5C2254B0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020340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896926-F365-4FC9-9FF3-0DD0749CEB9B}" type="datetimeFigureOut">
              <a:rPr lang="fr-FR" smtClean="0"/>
              <a:t>27/01/2025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2E57F0-A141-49CE-9B54-F7B5C2254B0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898266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896926-F365-4FC9-9FF3-0DD0749CEB9B}" type="datetimeFigureOut">
              <a:rPr lang="fr-FR" smtClean="0"/>
              <a:t>27/01/2025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2E57F0-A141-49CE-9B54-F7B5C2254B0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169329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896926-F365-4FC9-9FF3-0DD0749CEB9B}" type="datetimeFigureOut">
              <a:rPr lang="fr-FR" smtClean="0"/>
              <a:t>27/01/2025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2E57F0-A141-49CE-9B54-F7B5C2254B0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260593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896926-F365-4FC9-9FF3-0DD0749CEB9B}" type="datetimeFigureOut">
              <a:rPr lang="fr-FR" smtClean="0"/>
              <a:t>27/01/2025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2E57F0-A141-49CE-9B54-F7B5C2254B0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215749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896926-F365-4FC9-9FF3-0DD0749CEB9B}" type="datetimeFigureOut">
              <a:rPr lang="fr-FR" smtClean="0"/>
              <a:t>27/01/202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2E57F0-A141-49CE-9B54-F7B5C2254B0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603568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92325" y="657506"/>
            <a:ext cx="7207349" cy="2771494"/>
          </a:xfrm>
          <a:prstGeom prst="rect">
            <a:avLst/>
          </a:prstGeom>
        </p:spPr>
      </p:pic>
      <p:sp>
        <p:nvSpPr>
          <p:cNvPr id="6" name="Rectangle 5"/>
          <p:cNvSpPr/>
          <p:nvPr/>
        </p:nvSpPr>
        <p:spPr>
          <a:xfrm>
            <a:off x="2847974" y="3637687"/>
            <a:ext cx="6962775" cy="147732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Figure 3. Statistical maps showing the results of S</a:t>
            </a:r>
            <a:r>
              <a:rPr lang="en-US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x*Genotype interaction generated using f</a:t>
            </a:r>
            <a:r>
              <a:rPr lang="en-GB" sz="1200" b="1" dirty="0" err="1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ull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factorial statistical comparison of 30-ICA derived DMN at 4 months of age.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Subject-specific DMN maps were included in the analysis and inter-group analysis was carried out in SPM. Statistical results (red, blue  - t values, </a:t>
            </a:r>
            <a:r>
              <a:rPr lang="en-GB" sz="1200" dirty="0" err="1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hresholded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for p&lt;0.02, </a:t>
            </a:r>
            <a:r>
              <a:rPr lang="en-GB" sz="1200" dirty="0" err="1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uncorr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with minimal cluster size of 20 voxels) are overlaid on average maps of the DMN component.</a:t>
            </a:r>
            <a:endParaRPr lang="fr-FR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7" name="ZoneTexte 6"/>
          <p:cNvSpPr txBox="1"/>
          <p:nvPr/>
        </p:nvSpPr>
        <p:spPr>
          <a:xfrm>
            <a:off x="323850" y="171450"/>
            <a:ext cx="19718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Supplemental Fig 3</a:t>
            </a:r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2284925821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83</Words>
  <Application>Microsoft Office PowerPoint</Application>
  <PresentationFormat>Grand écran</PresentationFormat>
  <Paragraphs>2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Harsan</dc:creator>
  <cp:lastModifiedBy>Harsan</cp:lastModifiedBy>
  <cp:revision>2</cp:revision>
  <dcterms:created xsi:type="dcterms:W3CDTF">2025-01-27T21:53:07Z</dcterms:created>
  <dcterms:modified xsi:type="dcterms:W3CDTF">2025-01-27T21:53:32Z</dcterms:modified>
</cp:coreProperties>
</file>